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6" d="100"/>
          <a:sy n="66" d="100"/>
        </p:scale>
        <p:origin x="174" y="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ESRAA%20MD%20PAPER\ESRAA%20MD.xls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200" b="1" i="0" u="none" strike="noStrike" kern="1200" baseline="0">
                <a:solidFill>
                  <a:schemeClr val="dk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Diatery intakes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200" b="1" i="0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0"/>
      <c:rotY val="0"/>
      <c:depthPercent val="60"/>
      <c:rAngAx val="0"/>
      <c:perspective val="100"/>
    </c:view3D>
    <c:floor>
      <c:thickness val="0"/>
      <c:spPr>
        <a:solidFill>
          <a:schemeClr val="lt1">
            <a:lumMod val="95000"/>
          </a:schemeClr>
        </a:solidFill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4615805911644103"/>
          <c:y val="9.8044444444444462E-2"/>
          <c:w val="0.80989102039910665"/>
          <c:h val="0.49421928532294729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Sheet2!$D$2</c:f>
              <c:strCache>
                <c:ptCount val="1"/>
                <c:pt idx="0">
                  <c:v>Before education </c:v>
                </c:pt>
              </c:strCache>
            </c:strRef>
          </c:tx>
          <c:spPr>
            <a:solidFill>
              <a:schemeClr val="accent1">
                <a:alpha val="85000"/>
              </a:schemeClr>
            </a:solidFill>
            <a:ln w="9525" cap="flat" cmpd="sng" algn="ctr">
              <a:solidFill>
                <a:schemeClr val="accent1">
                  <a:lumMod val="75000"/>
                </a:schemeClr>
              </a:solidFill>
              <a:round/>
            </a:ln>
            <a:effectLst/>
            <a:sp3d contourW="9525">
              <a:contourClr>
                <a:schemeClr val="accent1">
                  <a:lumMod val="75000"/>
                </a:schemeClr>
              </a:contourClr>
            </a:sp3d>
          </c:spPr>
          <c:invertIfNegative val="0"/>
          <c:cat>
            <c:strRef>
              <c:f>Sheet2!$C$3:$C$16</c:f>
              <c:strCache>
                <c:ptCount val="13"/>
                <c:pt idx="0">
                  <c:v>Caloric intake </c:v>
                </c:pt>
                <c:pt idx="1">
                  <c:v>Carbohydrate </c:v>
                </c:pt>
                <c:pt idx="2">
                  <c:v>Fat </c:v>
                </c:pt>
                <c:pt idx="3">
                  <c:v>Protein </c:v>
                </c:pt>
                <c:pt idx="4">
                  <c:v>Sodium </c:v>
                </c:pt>
                <c:pt idx="5">
                  <c:v>Potassium</c:v>
                </c:pt>
                <c:pt idx="6">
                  <c:v>Calcium </c:v>
                </c:pt>
                <c:pt idx="7">
                  <c:v>Phosphorus </c:v>
                </c:pt>
                <c:pt idx="8">
                  <c:v>Magnesium </c:v>
                </c:pt>
                <c:pt idx="9">
                  <c:v>Iron </c:v>
                </c:pt>
                <c:pt idx="10">
                  <c:v>Zinc </c:v>
                </c:pt>
                <c:pt idx="11">
                  <c:v>Copper </c:v>
                </c:pt>
                <c:pt idx="12">
                  <c:v>Vitamin C</c:v>
                </c:pt>
              </c:strCache>
            </c:strRef>
          </c:cat>
          <c:val>
            <c:numRef>
              <c:f>Sheet2!$D$3:$D$16</c:f>
              <c:numCache>
                <c:formatCode>General</c:formatCode>
                <c:ptCount val="14"/>
                <c:pt idx="0">
                  <c:v>52.5</c:v>
                </c:pt>
                <c:pt idx="1">
                  <c:v>7.82</c:v>
                </c:pt>
                <c:pt idx="2">
                  <c:v>33.450000000000003</c:v>
                </c:pt>
                <c:pt idx="3">
                  <c:v>1.61</c:v>
                </c:pt>
                <c:pt idx="4">
                  <c:v>1.8169999999999999</c:v>
                </c:pt>
                <c:pt idx="5">
                  <c:v>1.72</c:v>
                </c:pt>
                <c:pt idx="6">
                  <c:v>165.33</c:v>
                </c:pt>
                <c:pt idx="7">
                  <c:v>386</c:v>
                </c:pt>
                <c:pt idx="8">
                  <c:v>98.43</c:v>
                </c:pt>
                <c:pt idx="9">
                  <c:v>8.81</c:v>
                </c:pt>
                <c:pt idx="10">
                  <c:v>5.2</c:v>
                </c:pt>
                <c:pt idx="11">
                  <c:v>0.76</c:v>
                </c:pt>
                <c:pt idx="12">
                  <c:v>2.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870-4F88-94AB-9491D4E826E8}"/>
            </c:ext>
          </c:extLst>
        </c:ser>
        <c:ser>
          <c:idx val="1"/>
          <c:order val="1"/>
          <c:tx>
            <c:strRef>
              <c:f>Sheet2!$E$2</c:f>
              <c:strCache>
                <c:ptCount val="1"/>
                <c:pt idx="0">
                  <c:v>Ater education</c:v>
                </c:pt>
              </c:strCache>
            </c:strRef>
          </c:tx>
          <c:spPr>
            <a:solidFill>
              <a:schemeClr val="accent2">
                <a:alpha val="85000"/>
              </a:schemeClr>
            </a:solidFill>
            <a:ln w="9525" cap="flat" cmpd="sng" algn="ctr">
              <a:solidFill>
                <a:schemeClr val="accent2">
                  <a:lumMod val="75000"/>
                </a:schemeClr>
              </a:solidFill>
              <a:round/>
            </a:ln>
            <a:effectLst/>
            <a:sp3d contourW="9525">
              <a:contourClr>
                <a:schemeClr val="accent2">
                  <a:lumMod val="75000"/>
                </a:schemeClr>
              </a:contourClr>
            </a:sp3d>
          </c:spPr>
          <c:invertIfNegative val="0"/>
          <c:cat>
            <c:strRef>
              <c:f>Sheet2!$C$3:$C$16</c:f>
              <c:strCache>
                <c:ptCount val="13"/>
                <c:pt idx="0">
                  <c:v>Caloric intake </c:v>
                </c:pt>
                <c:pt idx="1">
                  <c:v>Carbohydrate </c:v>
                </c:pt>
                <c:pt idx="2">
                  <c:v>Fat </c:v>
                </c:pt>
                <c:pt idx="3">
                  <c:v>Protein </c:v>
                </c:pt>
                <c:pt idx="4">
                  <c:v>Sodium </c:v>
                </c:pt>
                <c:pt idx="5">
                  <c:v>Potassium</c:v>
                </c:pt>
                <c:pt idx="6">
                  <c:v>Calcium </c:v>
                </c:pt>
                <c:pt idx="7">
                  <c:v>Phosphorus </c:v>
                </c:pt>
                <c:pt idx="8">
                  <c:v>Magnesium </c:v>
                </c:pt>
                <c:pt idx="9">
                  <c:v>Iron </c:v>
                </c:pt>
                <c:pt idx="10">
                  <c:v>Zinc </c:v>
                </c:pt>
                <c:pt idx="11">
                  <c:v>Copper </c:v>
                </c:pt>
                <c:pt idx="12">
                  <c:v>Vitamin C</c:v>
                </c:pt>
              </c:strCache>
            </c:strRef>
          </c:cat>
          <c:val>
            <c:numRef>
              <c:f>Sheet2!$E$3:$E$16</c:f>
              <c:numCache>
                <c:formatCode>General</c:formatCode>
                <c:ptCount val="14"/>
                <c:pt idx="0">
                  <c:v>65.790000000000006</c:v>
                </c:pt>
                <c:pt idx="1">
                  <c:v>20</c:v>
                </c:pt>
                <c:pt idx="2">
                  <c:v>28.4</c:v>
                </c:pt>
                <c:pt idx="3">
                  <c:v>1.8</c:v>
                </c:pt>
                <c:pt idx="4">
                  <c:v>1.044</c:v>
                </c:pt>
                <c:pt idx="5">
                  <c:v>0.94</c:v>
                </c:pt>
                <c:pt idx="6">
                  <c:v>600.41</c:v>
                </c:pt>
                <c:pt idx="7">
                  <c:v>300.24</c:v>
                </c:pt>
                <c:pt idx="8">
                  <c:v>100.27</c:v>
                </c:pt>
                <c:pt idx="9">
                  <c:v>10.45</c:v>
                </c:pt>
                <c:pt idx="10">
                  <c:v>5.7</c:v>
                </c:pt>
                <c:pt idx="11">
                  <c:v>0.59</c:v>
                </c:pt>
                <c:pt idx="12">
                  <c:v>35.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870-4F88-94AB-9491D4E826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5"/>
        <c:shape val="box"/>
        <c:axId val="1600593376"/>
        <c:axId val="1600586720"/>
        <c:axId val="0"/>
      </c:bar3DChart>
      <c:catAx>
        <c:axId val="1600593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dk1">
                <a:lumMod val="75000"/>
                <a:lumOff val="2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cap="all" baseline="0">
                <a:solidFill>
                  <a:schemeClr val="dk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00586720"/>
        <c:crossesAt val="0.5"/>
        <c:auto val="1"/>
        <c:lblAlgn val="ctr"/>
        <c:lblOffset val="100"/>
        <c:noMultiLvlLbl val="0"/>
      </c:catAx>
      <c:valAx>
        <c:axId val="1600586720"/>
        <c:scaling>
          <c:logBase val="2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dk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005933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6.2713736560201794E-2"/>
          <c:y val="0.89725524721325201"/>
          <c:w val="0.88831850380213628"/>
          <c:h val="7.7814939616074802E-2"/>
        </c:manualLayout>
      </c:layout>
      <c:overlay val="0"/>
      <c:spPr>
        <a:solidFill>
          <a:schemeClr val="lt1">
            <a:lumMod val="95000"/>
            <a:alpha val="39000"/>
          </a:schemeClr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gradFill flip="none" rotWithShape="1">
      <a:gsLst>
        <a:gs pos="0">
          <a:schemeClr val="lt1"/>
        </a:gs>
        <a:gs pos="39000">
          <a:schemeClr val="lt1"/>
        </a:gs>
        <a:gs pos="100000">
          <a:schemeClr val="lt1">
            <a:lumMod val="75000"/>
          </a:schemeClr>
        </a:gs>
      </a:gsLst>
      <a:path path="circle">
        <a:fillToRect l="50000" t="-80000" r="50000" b="180000"/>
      </a:path>
      <a:tileRect/>
    </a:gradFill>
    <a:ln w="9525" cap="flat" cmpd="sng" algn="ctr">
      <a:solidFill>
        <a:schemeClr val="dk1">
          <a:lumMod val="25000"/>
          <a:lumOff val="7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88">
  <cs:axisTitle>
    <cs:lnRef idx="0"/>
    <cs:fillRef idx="0"/>
    <cs:effectRef idx="0"/>
    <cs:fontRef idx="minor">
      <a:schemeClr val="dk1">
        <a:lumMod val="75000"/>
        <a:lumOff val="25000"/>
      </a:schemeClr>
    </cs:fontRef>
    <cs:defRPr sz="1197" b="1" kern="1200"/>
  </cs:axisTitle>
  <cs:categoryAxis>
    <cs:lnRef idx="0"/>
    <cs:fillRef idx="0"/>
    <cs:effectRef idx="0"/>
    <cs:fontRef idx="minor">
      <a:schemeClr val="dk1">
        <a:lumMod val="75000"/>
        <a:lumOff val="25000"/>
      </a:schemeClr>
    </cs:fontRef>
    <cs:spPr>
      <a:ln w="190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1197" kern="1200" cap="all" baseline="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lt1"/>
          </a:gs>
          <a:gs pos="39000">
            <a:schemeClr val="lt1"/>
          </a:gs>
          <a:gs pos="100000">
            <a:schemeClr val="lt1">
              <a:lumMod val="75000"/>
            </a:schemeClr>
          </a:gs>
        </a:gsLst>
        <a:path path="circle">
          <a:fillToRect l="50000" t="-80000" r="50000" b="180000"/>
        </a:path>
        <a:tileRect/>
      </a:gradFill>
      <a:ln w="9525" cap="flat" cmpd="sng" algn="ctr">
        <a:solidFill>
          <a:schemeClr val="dk1">
            <a:lumMod val="25000"/>
            <a:lumOff val="7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dk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lt1"/>
    </cs:fontRef>
    <cs:spPr>
      <a:solidFill>
        <a:schemeClr val="dk1">
          <a:lumMod val="65000"/>
          <a:lumOff val="35000"/>
          <a:alpha val="75000"/>
        </a:schemeClr>
      </a:solidFill>
    </cs:spPr>
    <cs:defRPr sz="1197" b="1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phClr">
            <a:lumMod val="75000"/>
          </a:schemeClr>
        </a:solidFill>
        <a:round/>
      </a:ln>
    </cs:spPr>
  </cs:dataPoint>
  <cs:dataPoint3D>
    <cs:lnRef idx="0">
      <cs:styleClr val="auto"/>
    </cs:lnRef>
    <cs:fillRef idx="0">
      <cs:styleClr val="auto"/>
    </cs:fillRef>
    <cs:effectRef idx="0">
      <cs:styleClr val="auto"/>
    </cs:effectRef>
    <cs:fontRef idx="minor">
      <a:schemeClr val="dk1"/>
    </cs:fontRef>
    <cs:spPr>
      <a:solidFill>
        <a:schemeClr val="phClr">
          <a:alpha val="85000"/>
        </a:schemeClr>
      </a:solidFill>
      <a:ln w="9525" cap="flat" cmpd="sng" algn="ctr">
        <a:solidFill>
          <a:schemeClr val="phClr">
            <a:lumMod val="75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1750" cap="rnd">
        <a:solidFill>
          <a:schemeClr val="phClr">
            <a:alpha val="85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75000"/>
        <a:lumOff val="25000"/>
      </a:schemeClr>
    </cs:fontRef>
    <cs:spPr>
      <a:ln w="9525">
        <a:solidFill>
          <a:schemeClr val="dk1">
            <a:lumMod val="35000"/>
            <a:lumOff val="6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  <cs:spPr>
      <a:solidFill>
        <a:schemeClr val="lt1">
          <a:lumMod val="95000"/>
        </a:schemeClr>
      </a:solidFill>
      <a:sp3d/>
    </cs:spPr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</a:ln>
    </cs:spPr>
  </cs:leaderLine>
  <cs:legend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lt1">
          <a:lumMod val="95000"/>
          <a:alpha val="39000"/>
        </a:schemeClr>
      </a:solidFill>
    </cs:spPr>
    <cs:defRPr sz="1197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75000"/>
        <a:lumOff val="25000"/>
      </a:schemeClr>
    </cs:fontRef>
    <cs:spPr/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75000"/>
        <a:lumOff val="25000"/>
      </a:schemeClr>
    </cs:fontRef>
    <cs:defRPr sz="22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75000"/>
        <a:lumOff val="2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75000"/>
        <a:lumOff val="25000"/>
      </a:schemeClr>
    </cs:fontRef>
    <cs:spPr>
      <a:ln>
        <a:noFill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1ACDB3-AE27-4EE8-BFCD-CE015CC629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748A9DC-D2C6-46A4-BD8E-B3345AB97C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9B225F-5AED-445A-A6FD-83E2229474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FE0FA-CA99-4DBB-A279-AA8BB9FE8087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052F67-4747-4449-BADF-D4663D53C4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D60D47-AFA5-49BC-A6E9-EF987D6E9E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CFC4E-8D31-4B3D-992A-CBAE4EBB2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310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47514F-D8DD-4853-AD6A-5468B6C605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0C40EC-6100-45A1-B114-2B8F5BE47B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9A373B-5422-4AC6-BF97-1563CEBBBE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FE0FA-CA99-4DBB-A279-AA8BB9FE8087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DB5181-4FEC-47F6-8462-FB5A030316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B753F7-B281-4E5F-BFDE-411C4B16D5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CFC4E-8D31-4B3D-992A-CBAE4EBB2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8504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54EFD98-E0C6-45AB-91B6-0307313A15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8E653F-9C2A-4B63-866B-E2F4A75659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96EF4A-F259-472B-BB61-7BBCD6F66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FE0FA-CA99-4DBB-A279-AA8BB9FE8087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26D59D-4C49-415A-A287-CCE64887AA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3FF64A-7862-4575-ABEB-6155969295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CFC4E-8D31-4B3D-992A-CBAE4EBB2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820235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6987114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3ACDD9-8C0A-4152-AD49-2668B02805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127E2F-0CCE-4A27-B988-17F3DDE886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05F093-058B-46F6-883E-614480E3F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FE0FA-CA99-4DBB-A279-AA8BB9FE8087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58C083-8577-4DFB-A61C-2461200D23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BDC625-D405-492B-8075-0920353374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CFC4E-8D31-4B3D-992A-CBAE4EBB2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5899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621963-1362-407F-990B-DF9D757C4D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ADD0C5-FD8D-4835-879B-148F732FD2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8B3730-4A2A-4F51-8541-9698FD1A01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FE0FA-CA99-4DBB-A279-AA8BB9FE8087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C0C119-CC8E-4609-ADCC-D422483361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F66788-8923-4868-99E4-A621AD5716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CFC4E-8D31-4B3D-992A-CBAE4EBB2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302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EA7DC3-753F-4345-9968-9EEA3AA260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BE324D-D7A7-40E7-9A32-855E10AAFF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5C1F75-8923-43E4-BB59-CB6A30A929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DE5F03-60DE-47E5-A62D-5F7A405260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FE0FA-CA99-4DBB-A279-AA8BB9FE8087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55CBAA-5348-4366-9732-5F1C6908E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62E215-9C9C-410B-B9D9-F4DD22D51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CFC4E-8D31-4B3D-992A-CBAE4EBB2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2467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4BDC64-64F6-43D7-90E9-F97886CC4F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2DE7F7-444A-47A4-80DE-00AE78851A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E2EC5E-6A4E-4BEB-AC3E-67D9A7F334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B18BB7-6212-4E4C-AD5C-1C7EE3DA0C8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3DC5AB4-9749-4399-A34E-403806E8EA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717D243-BF91-4C99-ADC5-737F9FE57B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FE0FA-CA99-4DBB-A279-AA8BB9FE8087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DDFE4FC-9004-42F0-BCF0-A8424CEF63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8D17123-AC0D-42C7-88B8-95CE483AE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CFC4E-8D31-4B3D-992A-CBAE4EBB2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8650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0C464E-6245-4976-942B-F89221B12C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7ADA3AA-1387-440D-B355-7B3EAB474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FE0FA-CA99-4DBB-A279-AA8BB9FE8087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F3191F-6B11-4C9B-ACD9-FDFABE28CE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03C9970-F649-4A0A-AD55-A0E029DB04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CFC4E-8D31-4B3D-992A-CBAE4EBB2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1719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2EA9FBD-469C-47CF-8C13-05A721DC3D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FE0FA-CA99-4DBB-A279-AA8BB9FE8087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5C4ADA4-52DD-499A-9078-8679594217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9FD3EB5-8A2F-42F6-9DCC-747F82FABF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CFC4E-8D31-4B3D-992A-CBAE4EBB2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444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9C4BC9-236A-44A2-B47B-BA989CDF2A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6D54B6-2407-414D-AEE6-4DE827D110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1920169-1C8D-47F9-9A1C-846FE31AA5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E74DAC-3AA0-487C-9F29-6F966B3746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FE0FA-CA99-4DBB-A279-AA8BB9FE8087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D9B135-B950-46AC-8A13-4A4E6C59B0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A702F9-6421-4E12-A16A-B0CBE5F975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CFC4E-8D31-4B3D-992A-CBAE4EBB2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4575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98D458-DE74-4D70-863F-922C90DDFB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6201B57-0048-4D81-96EB-185912096E5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160A71-9B52-44E3-A2A4-B1463B2AB3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EE8D4C-D8FD-4307-8699-53AA55C95A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EFE0FA-CA99-4DBB-A279-AA8BB9FE8087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76BC4D-6E8B-4D57-86F7-292E341398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30CB83-5F06-44D1-A04F-EE57E892EC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1CFC4E-8D31-4B3D-992A-CBAE4EBB2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7643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2DA195-4A96-471F-8D83-A0BD0984D7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D7EB43-A8CD-4811-A782-965378167A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6E46E1-8C44-4556-BD81-94FFC0634B9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EFE0FA-CA99-4DBB-A279-AA8BB9FE8087}" type="datetimeFigureOut">
              <a:rPr lang="en-US" smtClean="0"/>
              <a:t>7/2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4402CE-6D7E-4913-B811-E79D4AE7FA4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407588-5B79-46A5-8196-2860A590DC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1CFC4E-8D31-4B3D-992A-CBAE4EBB28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246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2800" b="1" kern="100" dirty="0">
                <a:solidFill>
                  <a:schemeClr val="bg1"/>
                </a:solidFill>
                <a:effectLst/>
                <a:latin typeface="+mn-lt"/>
                <a:ea typeface="Aptos"/>
                <a:cs typeface="Arial" panose="020B0604020202020204" pitchFamily="34" charset="0"/>
              </a:rPr>
              <a:t>The Impact of Nutritional Management on the Growth and Nutritional Status of Children on Regular hemodialysis</a:t>
            </a:r>
            <a:endParaRPr lang="en-US" sz="2800" kern="100" dirty="0">
              <a:solidFill>
                <a:schemeClr val="bg1"/>
              </a:solidFill>
              <a:effectLst/>
              <a:latin typeface="+mn-lt"/>
              <a:ea typeface="Aptos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a</a:t>
            </a:r>
            <a:r>
              <a:rPr lang="en-US" sz="1800" dirty="0">
                <a:solidFill>
                  <a:schemeClr val="bg1"/>
                </a:solidFill>
                <a:effectLst/>
                <a:ea typeface="Aptos"/>
              </a:rPr>
              <a:t>assess </a:t>
            </a:r>
            <a:r>
              <a:rPr lang="en-US" dirty="0">
                <a:solidFill>
                  <a:schemeClr val="bg1"/>
                </a:solidFill>
              </a:rPr>
              <a:t>the Impact of nutritional management on the growth and nutrition of </a:t>
            </a:r>
            <a:r>
              <a:rPr lang="en-US" sz="1800" kern="100" dirty="0">
                <a:solidFill>
                  <a:schemeClr val="bg1"/>
                </a:solidFill>
                <a:effectLst/>
                <a:ea typeface="Aptos"/>
                <a:cs typeface="Arial" panose="020B0604020202020204" pitchFamily="34" charset="0"/>
              </a:rPr>
              <a:t>children on hemodialysis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722309" y="5685724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chemeClr val="bg1"/>
                </a:solidFill>
                <a:latin typeface="+mj-lt"/>
              </a:rPr>
              <a:t>Ahmed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Bef>
                <a:spcPts val="600"/>
              </a:spcBef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800" kern="100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Our study suggests that appropriately targeted nutrition education in children with CKD can improve weight centiles and MUAC and deranged renal biochemistry (including low serum albumin and raised serum potassium)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042502D-3315-4B6C-8086-913CDB393C13}"/>
              </a:ext>
            </a:extLst>
          </p:cNvPr>
          <p:cNvSpPr/>
          <p:nvPr/>
        </p:nvSpPr>
        <p:spPr>
          <a:xfrm>
            <a:off x="289255" y="2276896"/>
            <a:ext cx="1728385" cy="1095570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/>
              <a:t>50 children on haemodialysis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979ED3AA-A53C-42B7-A231-90E372C45419}"/>
              </a:ext>
            </a:extLst>
          </p:cNvPr>
          <p:cNvCxnSpPr/>
          <p:nvPr/>
        </p:nvCxnSpPr>
        <p:spPr>
          <a:xfrm>
            <a:off x="2184042" y="3600958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5CF779DB-5FEF-4489-86B0-D9345505ACBF}"/>
              </a:ext>
            </a:extLst>
          </p:cNvPr>
          <p:cNvCxnSpPr/>
          <p:nvPr/>
        </p:nvCxnSpPr>
        <p:spPr>
          <a:xfrm>
            <a:off x="2176645" y="3785903"/>
            <a:ext cx="563430" cy="464781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DB2268F1-D502-4CFA-B0BF-C06230FC2133}"/>
              </a:ext>
            </a:extLst>
          </p:cNvPr>
          <p:cNvCxnSpPr/>
          <p:nvPr/>
        </p:nvCxnSpPr>
        <p:spPr>
          <a:xfrm flipV="1">
            <a:off x="2176645" y="2901314"/>
            <a:ext cx="537173" cy="386036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ctangle 20">
            <a:extLst>
              <a:ext uri="{FF2B5EF4-FFF2-40B4-BE49-F238E27FC236}">
                <a16:creationId xmlns:a16="http://schemas.microsoft.com/office/drawing/2014/main" id="{CE3545A3-6401-439C-833A-695DA8975127}"/>
              </a:ext>
            </a:extLst>
          </p:cNvPr>
          <p:cNvSpPr/>
          <p:nvPr/>
        </p:nvSpPr>
        <p:spPr>
          <a:xfrm>
            <a:off x="289255" y="3603497"/>
            <a:ext cx="1735313" cy="1053688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>
                <a:solidFill>
                  <a:srgbClr val="65AA00"/>
                </a:solidFill>
              </a:rPr>
              <a:t>50 matched controls</a:t>
            </a:r>
          </a:p>
        </p:txBody>
      </p: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2F187AA7-39B8-484C-903D-BC382F5514C0}"/>
              </a:ext>
            </a:extLst>
          </p:cNvPr>
          <p:cNvCxnSpPr/>
          <p:nvPr/>
        </p:nvCxnSpPr>
        <p:spPr>
          <a:xfrm>
            <a:off x="4893107" y="3600082"/>
            <a:ext cx="715833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77BFD6B0-960E-430F-81A7-C4EA82A9FE2B}"/>
              </a:ext>
            </a:extLst>
          </p:cNvPr>
          <p:cNvCxnSpPr/>
          <p:nvPr/>
        </p:nvCxnSpPr>
        <p:spPr>
          <a:xfrm flipV="1">
            <a:off x="4873074" y="2839806"/>
            <a:ext cx="628373" cy="468037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DE506708-A28A-4977-9106-FDBB045480DA}"/>
              </a:ext>
            </a:extLst>
          </p:cNvPr>
          <p:cNvCxnSpPr/>
          <p:nvPr/>
        </p:nvCxnSpPr>
        <p:spPr>
          <a:xfrm>
            <a:off x="4893070" y="3875084"/>
            <a:ext cx="613837" cy="461154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Rectangle 29">
            <a:extLst>
              <a:ext uri="{FF2B5EF4-FFF2-40B4-BE49-F238E27FC236}">
                <a16:creationId xmlns:a16="http://schemas.microsoft.com/office/drawing/2014/main" id="{8BD8E721-59A2-43F4-9885-95EA9A7855B2}"/>
              </a:ext>
            </a:extLst>
          </p:cNvPr>
          <p:cNvSpPr/>
          <p:nvPr/>
        </p:nvSpPr>
        <p:spPr>
          <a:xfrm>
            <a:off x="2961707" y="3573110"/>
            <a:ext cx="1735313" cy="1076483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>
                <a:solidFill>
                  <a:srgbClr val="AA0065"/>
                </a:solidFill>
              </a:rPr>
              <a:t>Nutritional education for 6 months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1AC2BC3F-3F5D-44BD-85D8-C6561BEA99AB}"/>
              </a:ext>
            </a:extLst>
          </p:cNvPr>
          <p:cNvSpPr/>
          <p:nvPr/>
        </p:nvSpPr>
        <p:spPr>
          <a:xfrm>
            <a:off x="2954237" y="2258411"/>
            <a:ext cx="1728385" cy="1156046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2000" b="1" dirty="0"/>
              <a:t>Growth, nutrition, and laboratory  assessment </a:t>
            </a:r>
          </a:p>
        </p:txBody>
      </p:sp>
      <p:sp>
        <p:nvSpPr>
          <p:cNvPr id="32" name="Up Arrow 10">
            <a:extLst>
              <a:ext uri="{FF2B5EF4-FFF2-40B4-BE49-F238E27FC236}">
                <a16:creationId xmlns:a16="http://schemas.microsoft.com/office/drawing/2014/main" id="{CDB17AB2-1C24-44D0-92E8-4AD17B584349}"/>
              </a:ext>
            </a:extLst>
          </p:cNvPr>
          <p:cNvSpPr/>
          <p:nvPr/>
        </p:nvSpPr>
        <p:spPr>
          <a:xfrm>
            <a:off x="5621457" y="2157735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Up Arrow 10">
            <a:extLst>
              <a:ext uri="{FF2B5EF4-FFF2-40B4-BE49-F238E27FC236}">
                <a16:creationId xmlns:a16="http://schemas.microsoft.com/office/drawing/2014/main" id="{259279FF-BD00-4E60-8C17-04978E4F462D}"/>
              </a:ext>
            </a:extLst>
          </p:cNvPr>
          <p:cNvSpPr/>
          <p:nvPr/>
        </p:nvSpPr>
        <p:spPr>
          <a:xfrm>
            <a:off x="5673787" y="3547350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" name="Up Arrow 10">
            <a:extLst>
              <a:ext uri="{FF2B5EF4-FFF2-40B4-BE49-F238E27FC236}">
                <a16:creationId xmlns:a16="http://schemas.microsoft.com/office/drawing/2014/main" id="{68CF48C0-07D2-4BDE-94D0-75D2CF2415D1}"/>
              </a:ext>
            </a:extLst>
          </p:cNvPr>
          <p:cNvSpPr/>
          <p:nvPr/>
        </p:nvSpPr>
        <p:spPr>
          <a:xfrm>
            <a:off x="5686148" y="4598576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327BC0C-4F25-4BA4-8E8B-EF17D61F8AD9}"/>
              </a:ext>
            </a:extLst>
          </p:cNvPr>
          <p:cNvSpPr txBox="1"/>
          <p:nvPr/>
        </p:nvSpPr>
        <p:spPr>
          <a:xfrm>
            <a:off x="6089508" y="3091423"/>
            <a:ext cx="210463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Caloric intak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530EA23-52B3-4E52-851C-FD4257D760EE}"/>
              </a:ext>
            </a:extLst>
          </p:cNvPr>
          <p:cNvSpPr txBox="1"/>
          <p:nvPr/>
        </p:nvSpPr>
        <p:spPr>
          <a:xfrm>
            <a:off x="6091012" y="4071160"/>
            <a:ext cx="25431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at, Salt, K, and P intake </a:t>
            </a:r>
          </a:p>
        </p:txBody>
      </p:sp>
      <p:sp>
        <p:nvSpPr>
          <p:cNvPr id="36" name="Up Arrow 12">
            <a:extLst>
              <a:ext uri="{FF2B5EF4-FFF2-40B4-BE49-F238E27FC236}">
                <a16:creationId xmlns:a16="http://schemas.microsoft.com/office/drawing/2014/main" id="{881F7280-F44C-4687-A81B-F09421F0E681}"/>
              </a:ext>
            </a:extLst>
          </p:cNvPr>
          <p:cNvSpPr/>
          <p:nvPr/>
        </p:nvSpPr>
        <p:spPr>
          <a:xfrm rot="10800000">
            <a:off x="5647009" y="2480363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8F762B3-F97E-417D-A879-215C506A4FD9}"/>
              </a:ext>
            </a:extLst>
          </p:cNvPr>
          <p:cNvSpPr txBox="1"/>
          <p:nvPr/>
        </p:nvSpPr>
        <p:spPr>
          <a:xfrm>
            <a:off x="6096000" y="3544179"/>
            <a:ext cx="24442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/>
              <a:t>Protein and Ca intak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587FD2E-5A4A-4008-BF05-97B5D660C4F6}"/>
              </a:ext>
            </a:extLst>
          </p:cNvPr>
          <p:cNvSpPr txBox="1"/>
          <p:nvPr/>
        </p:nvSpPr>
        <p:spPr>
          <a:xfrm>
            <a:off x="6068393" y="2157735"/>
            <a:ext cx="23540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eight and MUAC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20687B6-D37D-451A-9133-694679410277}"/>
              </a:ext>
            </a:extLst>
          </p:cNvPr>
          <p:cNvSpPr txBox="1"/>
          <p:nvPr/>
        </p:nvSpPr>
        <p:spPr>
          <a:xfrm>
            <a:off x="4762784" y="1755832"/>
            <a:ext cx="38713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emodialysis group after 6 months </a:t>
            </a:r>
          </a:p>
        </p:txBody>
      </p:sp>
      <p:sp>
        <p:nvSpPr>
          <p:cNvPr id="37" name="Up Arrow 10">
            <a:extLst>
              <a:ext uri="{FF2B5EF4-FFF2-40B4-BE49-F238E27FC236}">
                <a16:creationId xmlns:a16="http://schemas.microsoft.com/office/drawing/2014/main" id="{BAFD3094-8038-4D79-8AFA-68A781E2F354}"/>
              </a:ext>
            </a:extLst>
          </p:cNvPr>
          <p:cNvSpPr/>
          <p:nvPr/>
        </p:nvSpPr>
        <p:spPr>
          <a:xfrm>
            <a:off x="5644790" y="3133927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Up Arrow 12">
            <a:extLst>
              <a:ext uri="{FF2B5EF4-FFF2-40B4-BE49-F238E27FC236}">
                <a16:creationId xmlns:a16="http://schemas.microsoft.com/office/drawing/2014/main" id="{CD86942F-2CF0-4721-A9A9-E0E165A5EDCD}"/>
              </a:ext>
            </a:extLst>
          </p:cNvPr>
          <p:cNvSpPr/>
          <p:nvPr/>
        </p:nvSpPr>
        <p:spPr>
          <a:xfrm rot="10800000">
            <a:off x="5678617" y="3916038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936A167-5698-4F4C-936D-A2711342E8C7}"/>
              </a:ext>
            </a:extLst>
          </p:cNvPr>
          <p:cNvSpPr txBox="1"/>
          <p:nvPr/>
        </p:nvSpPr>
        <p:spPr>
          <a:xfrm>
            <a:off x="6176638" y="2640015"/>
            <a:ext cx="15456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EW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7D4455D-C67F-495E-9577-13AE9C83BE99}"/>
              </a:ext>
            </a:extLst>
          </p:cNvPr>
          <p:cNvSpPr txBox="1"/>
          <p:nvPr/>
        </p:nvSpPr>
        <p:spPr>
          <a:xfrm>
            <a:off x="6176638" y="4532275"/>
            <a:ext cx="22457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Hb, serum Ca and Albumin</a:t>
            </a:r>
          </a:p>
        </p:txBody>
      </p:sp>
      <p:sp>
        <p:nvSpPr>
          <p:cNvPr id="43" name="Up Arrow 12">
            <a:extLst>
              <a:ext uri="{FF2B5EF4-FFF2-40B4-BE49-F238E27FC236}">
                <a16:creationId xmlns:a16="http://schemas.microsoft.com/office/drawing/2014/main" id="{2F103F66-BE98-4169-9564-31106364C788}"/>
              </a:ext>
            </a:extLst>
          </p:cNvPr>
          <p:cNvSpPr/>
          <p:nvPr/>
        </p:nvSpPr>
        <p:spPr>
          <a:xfrm rot="10800000">
            <a:off x="5693576" y="5055042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A5BC871-147E-4D31-B3C0-FF56FC45F850}"/>
              </a:ext>
            </a:extLst>
          </p:cNvPr>
          <p:cNvSpPr txBox="1"/>
          <p:nvPr/>
        </p:nvSpPr>
        <p:spPr>
          <a:xfrm>
            <a:off x="6089508" y="5149039"/>
            <a:ext cx="21046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erum K, P, PTH, uric acid</a:t>
            </a:r>
          </a:p>
        </p:txBody>
      </p:sp>
      <p:graphicFrame>
        <p:nvGraphicFramePr>
          <p:cNvPr id="33" name="Chart 32">
            <a:extLst>
              <a:ext uri="{FF2B5EF4-FFF2-40B4-BE49-F238E27FC236}">
                <a16:creationId xmlns:a16="http://schemas.microsoft.com/office/drawing/2014/main" id="{4E00797D-C2B7-464A-848A-8349ABFD06F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0872889"/>
              </p:ext>
            </p:extLst>
          </p:nvPr>
        </p:nvGraphicFramePr>
        <p:xfrm>
          <a:off x="8496446" y="1592791"/>
          <a:ext cx="3695554" cy="40754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138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ba mostafa</dc:creator>
  <cp:lastModifiedBy>heba852</cp:lastModifiedBy>
  <cp:revision>6</cp:revision>
  <dcterms:created xsi:type="dcterms:W3CDTF">2025-02-08T01:52:43Z</dcterms:created>
  <dcterms:modified xsi:type="dcterms:W3CDTF">2025-07-29T20:49:46Z</dcterms:modified>
</cp:coreProperties>
</file>